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5">
  <p:sldMasterIdLst>
    <p:sldMasterId id="2147483648" r:id="rId1"/>
  </p:sldMasterIdLst>
  <p:notesMasterIdLst>
    <p:notesMasterId r:id="rId3"/>
  </p:notesMasterIdLst>
  <p:sldIdLst>
    <p:sldId id="355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118CDF"/>
    <a:srgbClr val="16A8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749" autoAdjust="0"/>
    <p:restoredTop sz="88454" autoAdjust="0"/>
  </p:normalViewPr>
  <p:slideViewPr>
    <p:cSldViewPr>
      <p:cViewPr varScale="1">
        <p:scale>
          <a:sx n="85" d="100"/>
          <a:sy n="85" d="100"/>
        </p:scale>
        <p:origin x="2886" y="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2FAFD0-EF8C-554B-B034-4442DE591FA0}" type="datetimeFigureOut">
              <a:rPr lang="en-US" smtClean="0"/>
              <a:t>2/1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1FB10-D472-764B-87F9-C134BDEA3E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1839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1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4337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18408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8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8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24877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38122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3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809491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47935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25369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913728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44652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1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7" y="36408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10" y="191348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13967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58140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1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DDACA6-1E61-4259-AAC1-263401F132C0}" type="datetimeFigureOut">
              <a:rPr lang="en-US" smtClean="0"/>
              <a:t>2/12/20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2E525C-54E1-498F-B230-B106E6C8DB3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43347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89161992"/>
              </p:ext>
            </p:extLst>
          </p:nvPr>
        </p:nvGraphicFramePr>
        <p:xfrm>
          <a:off x="123022" y="609600"/>
          <a:ext cx="3763178" cy="570136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4103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96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7526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 Gro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dy weight (g) 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Y REPORT*</a:t>
                      </a:r>
                      <a:endParaRPr lang="en-US" sz="800" b="1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.99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515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g</a:t>
                      </a:r>
                      <a:endParaRPr lang="en-US" sz="800" b="1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2860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51598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g</a:t>
                      </a:r>
                      <a:endParaRPr lang="en-US" sz="800" b="1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.2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p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mg/kg C458</a:t>
                      </a:r>
                      <a:endParaRPr lang="en-US" sz="800" b="1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30319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trol Littermate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.00g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 abnormalities</a:t>
                      </a:r>
                      <a:endParaRPr lang="en-US" sz="8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44812" marR="44812" marT="0" marB="0" anchor="ctr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93269" y="228600"/>
            <a:ext cx="67647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s 3.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Histology results for 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57BL/6 adult and newborn mice treated with </a:t>
            </a:r>
            <a:r>
              <a:rPr lang="en-US" alt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458</a:t>
            </a:r>
            <a:endParaRPr 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00022902"/>
              </p:ext>
            </p:extLst>
          </p:nvPr>
        </p:nvGraphicFramePr>
        <p:xfrm>
          <a:off x="3962400" y="609600"/>
          <a:ext cx="2743200" cy="4389628"/>
        </p:xfrm>
        <a:graphic>
          <a:graphicData uri="http://schemas.openxmlformats.org/drawingml/2006/table">
            <a:tbl>
              <a:tblPr firstRow="1" firstCol="1" bandRow="1">
                <a:tableStyleId>{5940675A-B579-460E-94D1-54222C63F5DA}</a:tableStyleId>
              </a:tblPr>
              <a:tblGrid>
                <a:gridCol w="38713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272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0668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350520"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x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ISTOLOGY REPORT</a:t>
                      </a:r>
                      <a:endParaRPr lang="en-US" sz="800" b="1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6233">
                <a:tc rowSpan="7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971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  <a:endParaRPr lang="en-US" sz="80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none" strike="noStrike" kern="1200" baseline="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ythroid</a:t>
                      </a: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yperplasia, moderate, diffus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  <a:endParaRPr lang="en-US" sz="80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ary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mg/kg C458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09551">
                <a:tc rowSpan="7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ain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ocytic meningitis, mild, multifocal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art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ng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iver</a:t>
                      </a:r>
                      <a:endParaRPr lang="en-US" sz="80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leen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idney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623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ary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hicle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histologic abnormalities</a:t>
                      </a:r>
                      <a:endParaRPr lang="en-US" sz="800" dirty="0">
                        <a:solidFill>
                          <a:schemeClr val="bg2"/>
                        </a:solidFill>
                        <a:effectLst/>
                        <a:latin typeface="Arial" panose="020B0604020202020204" pitchFamily="34" charset="0"/>
                        <a:ea typeface="Calibri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861949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1372f5f-8e19-4efb-8afe-8eac20a980c4}" enabled="1" method="Standard" siteId="{a25fff9c-3f63-4fb2-9a8a-d9bdd0321f9a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50712</TotalTime>
  <Words>305</Words>
  <Application>Microsoft Office PowerPoint</Application>
  <PresentationFormat>On-screen Show (4:3)</PresentationFormat>
  <Paragraphs>1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Mayo Clini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ey A Trushin</dc:creator>
  <cp:lastModifiedBy>Trushin, Sergey A., Ph.D.</cp:lastModifiedBy>
  <cp:revision>604</cp:revision>
  <cp:lastPrinted>2022-11-09T15:46:24Z</cp:lastPrinted>
  <dcterms:created xsi:type="dcterms:W3CDTF">2020-01-31T17:27:01Z</dcterms:created>
  <dcterms:modified xsi:type="dcterms:W3CDTF">2025-02-12T20:39:45Z</dcterms:modified>
</cp:coreProperties>
</file>